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6781800" cy="9882188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96E270B-2CEB-462A-9480-6E8EA9BC375F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57E6406-8007-4E19-902B-B218E10FF9F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E55B30E-84FB-404F-86D0-5CB4CF8F8F5D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AC9AB26-06DE-4DEF-AC0C-FC6414511BE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06362A-86F9-4E32-88B4-3070304FECA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9DAA3BB-F70C-4937-8A63-3552462CAED8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C5DE6FA-7D50-4C91-9C04-C52BC272305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F035816-FB50-48C4-AD41-C6B2FA978F69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EA2959C-BEA7-4634-AD59-AE2205A5481B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AF610F-FCC2-40E4-8AC5-F74389739D1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2D56EAB-DC1E-4D80-9360-E0ACF030237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9E9B6B-04A6-4ED7-BB56-9FD80FE75D8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94C60D8-F446-44F3-9909-C2A635C6CAE8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>
            <a:off x="981000" y="755640"/>
            <a:ext cx="4732560" cy="2203560"/>
          </a:xfrm>
          <a:prstGeom prst="rect">
            <a:avLst/>
          </a:prstGeom>
          <a:ln w="0">
            <a:noFill/>
          </a:ln>
        </p:spPr>
      </p:pic>
      <p:sp>
        <p:nvSpPr>
          <p:cNvPr id="42" name=""/>
          <p:cNvSpPr/>
          <p:nvPr/>
        </p:nvSpPr>
        <p:spPr>
          <a:xfrm>
            <a:off x="907920" y="61128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907920" y="3002040"/>
            <a:ext cx="43200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"/>
          <p:cNvSpPr/>
          <p:nvPr/>
        </p:nvSpPr>
        <p:spPr>
          <a:xfrm>
            <a:off x="981000" y="5724360"/>
            <a:ext cx="4608720" cy="1189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spcBef>
                <a:spcPts val="75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s-ES" sz="1200" spc="-1" strike="noStrike">
                <a:solidFill>
                  <a:srgbClr val="000000"/>
                </a:solidFill>
                <a:latin typeface="Arial"/>
              </a:rPr>
              <a:t>Supplementary Figure S4.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</a:rPr>
              <a:t>Quantitative chromatin immunoprecipitation for Mecp2. Mecp2 occupancy is observed for the genes in panel A in the wild-type mice. Mecp2 is absent for the genes in panel B. White bars, wild-type mice; black bars, Mecp2 null mice. A negative control IgG antiserum and a positive control total histone H3 are also shown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5" name="" descr=""/>
          <p:cNvPicPr/>
          <p:nvPr/>
        </p:nvPicPr>
        <p:blipFill>
          <a:blip r:embed="rId2"/>
          <a:stretch/>
        </p:blipFill>
        <p:spPr>
          <a:xfrm>
            <a:off x="981000" y="3006720"/>
            <a:ext cx="4743360" cy="2212920"/>
          </a:xfrm>
          <a:prstGeom prst="rect">
            <a:avLst/>
          </a:prstGeom>
          <a:ln w="0">
            <a:noFill/>
          </a:ln>
        </p:spPr>
      </p:pic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3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10-19T10:33:24Z</dcterms:created>
  <dc:creator>rgonzalezu</dc:creator>
  <dc:description/>
  <dc:language>en-US</dc:language>
  <cp:lastModifiedBy>h501xmeb</cp:lastModifiedBy>
  <dcterms:modified xsi:type="dcterms:W3CDTF">2008-10-22T08:10:04Z</dcterms:modified>
  <cp:revision>22</cp:revision>
  <dc:subject/>
  <dc:title>Diapositiva 1</dc:title>
</cp:coreProperties>
</file>